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3" r:id="rId2"/>
  </p:sldIdLst>
  <p:sldSz cx="9144000" cy="6858000" type="screen4x3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0E0E0"/>
    <a:srgbClr val="ECEC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essuno stile, griglia tabel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8" autoAdjust="0"/>
    <p:restoredTop sz="90598" autoAdjust="0"/>
  </p:normalViewPr>
  <p:slideViewPr>
    <p:cSldViewPr>
      <p:cViewPr>
        <p:scale>
          <a:sx n="110" d="100"/>
          <a:sy n="110" d="100"/>
        </p:scale>
        <p:origin x="-18" y="19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7B53EF-3AE7-484E-9BAC-564CAAF4E700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DA31B0-2556-4684-8750-BF1D8261D7A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9989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60961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36762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6778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9888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2904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04353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31864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58313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91545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869255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96548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75357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7662942"/>
              </p:ext>
            </p:extLst>
          </p:nvPr>
        </p:nvGraphicFramePr>
        <p:xfrm>
          <a:off x="251520" y="836712"/>
          <a:ext cx="3888431" cy="4391977"/>
        </p:xfrm>
        <a:graphic>
          <a:graphicData uri="http://schemas.openxmlformats.org/drawingml/2006/table">
            <a:tbl>
              <a:tblPr/>
              <a:tblGrid>
                <a:gridCol w="648072"/>
                <a:gridCol w="525796"/>
                <a:gridCol w="660299"/>
                <a:gridCol w="770387"/>
                <a:gridCol w="565695"/>
                <a:gridCol w="718182"/>
              </a:tblGrid>
              <a:tr h="360040">
                <a:tc>
                  <a:txBody>
                    <a:bodyPr/>
                    <a:lstStyle/>
                    <a:p>
                      <a:pPr algn="ctr" fontAlgn="t"/>
                      <a:r>
                        <a:rPr lang="it-IT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HL-MUT </a:t>
                      </a:r>
                      <a:r>
                        <a:rPr lang="it-IT" sz="1000" b="1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atients</a:t>
                      </a:r>
                      <a:r>
                        <a:rPr lang="it-IT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</a:p>
                  </a:txBody>
                  <a:tcPr marL="7155" marR="7155" marT="715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tage at </a:t>
                      </a:r>
                      <a:r>
                        <a:rPr lang="it-IT" sz="1000" b="1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iagnosis</a:t>
                      </a:r>
                      <a:endParaRPr lang="it-IT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155" marR="7155" marT="715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000" b="1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uhrman</a:t>
                      </a:r>
                      <a:r>
                        <a:rPr lang="it-IT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's </a:t>
                      </a:r>
                      <a:r>
                        <a:rPr lang="it-IT" sz="1000" b="1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rade</a:t>
                      </a:r>
                      <a:endParaRPr lang="it-IT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155" marR="7155" marT="715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t"/>
                      <a:r>
                        <a:rPr lang="it-IT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D107a+NK </a:t>
                      </a:r>
                      <a:r>
                        <a:rPr lang="it-IT" sz="1000" b="1" i="0" u="none" strike="noStrike" dirty="0" err="1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ells</a:t>
                      </a:r>
                      <a:endParaRPr lang="it-IT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155" marR="7155" marT="7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307662">
                <a:tc>
                  <a:txBody>
                    <a:bodyPr/>
                    <a:lstStyle/>
                    <a:p>
                      <a:pPr algn="ctr" fontAlgn="t"/>
                      <a:r>
                        <a:rPr lang="it-IT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7155" marR="7155" marT="715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7155" marR="7155" marT="715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7155" marR="7155" marT="715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56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49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KI-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309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a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309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a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I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309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b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I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50254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2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I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,7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50254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3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V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50254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3a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I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309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2b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I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309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a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I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309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b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309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b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I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309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3a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I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309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2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3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50254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3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3a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50254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4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2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50254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5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a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50254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a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50254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7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a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50254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8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2a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50254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9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b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309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b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309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1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2a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309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2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2a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  <a:endParaRPr lang="it-IT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309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3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3a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I</a:t>
                      </a:r>
                    </a:p>
                  </a:txBody>
                  <a:tcPr marL="7155" marR="7155" marT="71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1%</a:t>
                      </a:r>
                      <a:endParaRPr lang="it-IT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7" name="CasellaDiTesto 6"/>
          <p:cNvSpPr txBox="1"/>
          <p:nvPr/>
        </p:nvSpPr>
        <p:spPr>
          <a:xfrm>
            <a:off x="179512" y="590491"/>
            <a:ext cx="46805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it-IT" sz="1000" b="1" smtClean="0">
                <a:latin typeface="Times New Roman" pitchFamily="18" charset="0"/>
                <a:cs typeface="Times New Roman" pitchFamily="18" charset="0"/>
              </a:rPr>
              <a:t>Table </a:t>
            </a:r>
            <a:r>
              <a:rPr lang="en-US" altLang="it-IT" sz="1000" b="1" smtClean="0">
                <a:latin typeface="Times New Roman" pitchFamily="18" charset="0"/>
                <a:cs typeface="Times New Roman" pitchFamily="18" charset="0"/>
              </a:rPr>
              <a:t>S2</a:t>
            </a:r>
            <a:r>
              <a:rPr lang="en-US" altLang="it-IT" sz="100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altLang="it-IT" sz="1000" dirty="0" smtClean="0">
                <a:latin typeface="Times New Roman" pitchFamily="18" charset="0"/>
                <a:cs typeface="Times New Roman" pitchFamily="18" charset="0"/>
              </a:rPr>
              <a:t>Detailed characteristics of 23 VHL-MUT-RCC patients</a:t>
            </a:r>
            <a:endParaRPr lang="it-IT" sz="10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73</TotalTime>
  <Words>226</Words>
  <Application>Microsoft Office PowerPoint</Application>
  <PresentationFormat>Presentazione su schermo (4:3)</PresentationFormat>
  <Paragraphs>149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CALA</dc:creator>
  <cp:lastModifiedBy>Genomica Funzionale</cp:lastModifiedBy>
  <cp:revision>615</cp:revision>
  <dcterms:created xsi:type="dcterms:W3CDTF">2016-04-07T07:01:43Z</dcterms:created>
  <dcterms:modified xsi:type="dcterms:W3CDTF">2018-10-10T10:12:40Z</dcterms:modified>
</cp:coreProperties>
</file>